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smtClean="0"/>
              <a:t>Figure </a:t>
            </a:r>
            <a:r>
              <a:rPr lang="en-GB" sz="1600" smtClean="0"/>
              <a:t>S42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STK11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2wtk_C 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2wtk_C 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85720" y="214290"/>
            <a:ext cx="3500462" cy="28125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142852"/>
            <a:ext cx="3643338" cy="292895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85720" y="3143249"/>
            <a:ext cx="3500462" cy="27860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0192" y="3214687"/>
            <a:ext cx="3648088" cy="271464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86</cp:revision>
  <dcterms:created xsi:type="dcterms:W3CDTF">2018-05-10T07:33:24Z</dcterms:created>
  <dcterms:modified xsi:type="dcterms:W3CDTF">2018-05-29T07:46:31Z</dcterms:modified>
</cp:coreProperties>
</file>